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1771F-C893-47DC-A5E1-E9208D42F2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AC39A-6EDA-4262-B730-E319D282B8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3995C-C028-43D6-9C79-FD0A86AA95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2FE3F-948A-4EE7-8BFA-A0F5526C80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21DEA-10C4-4F7C-8F97-F6DB11E414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86915-178B-4277-8B8C-EE7C6C2102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C9B273-AE8E-497E-8B4E-8FB7E7BAF5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E5E06-1000-48AA-BB03-FC6F01CB28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47FE9-6E91-47B8-BBC5-5A6415FC38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99EA6-B237-44CB-B5C8-EBFDEFF319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D19AC-8911-4494-A38B-EA58271E3F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542D65-17C0-4099-BC30-31C3B03880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맑은 고딕"/>
              </a:rPr>
              <a:t>2022-04-06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794E92-FBD2-4F1A-8479-F87374DCFA8F}" type="slidenum"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119160" y="110880"/>
            <a:ext cx="11958480" cy="795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Supplementary Material 1. Trends in age-standardized mortality rate of infectious disease by 10 selected groups using Joinpoint analyses in Republic of Korea, 1997-2019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42" name="그림 4" descr=""/>
          <p:cNvPicPr/>
          <p:nvPr/>
        </p:nvPicPr>
        <p:blipFill>
          <a:blip r:embed="rId1"/>
          <a:srcRect l="0" t="0" r="0" b="9808"/>
          <a:stretch/>
        </p:blipFill>
        <p:spPr>
          <a:xfrm>
            <a:off x="858960" y="1355760"/>
            <a:ext cx="9947160" cy="2967120"/>
          </a:xfrm>
          <a:prstGeom prst="rect">
            <a:avLst/>
          </a:prstGeom>
          <a:ln w="0">
            <a:noFill/>
          </a:ln>
        </p:spPr>
      </p:pic>
      <p:sp>
        <p:nvSpPr>
          <p:cNvPr id="43" name="직사각형 5"/>
          <p:cNvSpPr/>
          <p:nvPr/>
        </p:nvSpPr>
        <p:spPr>
          <a:xfrm>
            <a:off x="858960" y="4462560"/>
            <a:ext cx="9947160" cy="776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75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baseline="30000">
                <a:solidFill>
                  <a:srgbClr val="000000"/>
                </a:solidFill>
                <a:latin typeface="맑은 고딕"/>
                <a:ea typeface="Times New Roman"/>
              </a:rPr>
              <a:t>1</a:t>
            </a:r>
            <a:r>
              <a:rPr b="0" lang="en-US" sz="14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AAPC: average annual percentage change in age-standardized mortality rate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  <a:p>
            <a:pPr algn="just">
              <a:lnSpc>
                <a:spcPct val="75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baseline="30000">
                <a:solidFill>
                  <a:srgbClr val="000000"/>
                </a:solidFill>
                <a:latin typeface="맑은 고딕"/>
                <a:ea typeface="Times New Roman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APC: annual percentage change in age-standardized mortality rate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  <a:p>
            <a:pPr algn="just">
              <a:lnSpc>
                <a:spcPct val="75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* indicates that AAPC or APC are significantly different from zero at the alpha=0.05 level. 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10-21T11:55:57Z</dcterms:created>
  <dc:creator>mikumiku009@hotmail.com</dc:creator>
  <dc:description/>
  <dc:language>en-US</dc:language>
  <cp:lastModifiedBy>AppPower</cp:lastModifiedBy>
  <dcterms:modified xsi:type="dcterms:W3CDTF">2022-04-26T01:01:23Z</dcterms:modified>
  <cp:revision>5</cp:revision>
  <dc:subject/>
  <dc:title>PowerPoint 프레젠테이션</dc:title>
</cp:coreProperties>
</file>